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39543C-794F-43DB-B4FF-255E1CCAF70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385CCE-8AFB-48F9-99A3-30CD40E218A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B131AE-F3BA-45E5-8ABC-D429B8A96A7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1B704B-3725-4556-AD5B-1147CF7BDA3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EE6F93-F84C-4B6B-B264-2BA6650DF99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9794C7-3006-4FE0-B59A-0D0886AAACF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7CCEC1-1051-442D-B61C-A955BE14E26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008481-F6BA-4DD1-8056-39042F43C97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91057B-6FCC-485F-A3BF-140795865EF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DB4288-F577-497B-9D3B-DE9824351F4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30C0EA-A246-44F7-83D4-4570338FA25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C8B1D9-CB93-4D40-8944-ADCBFF19D6B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1627C0EE-393B-4B57-95D4-4ADD3AC588DA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Object 1" descr=""/>
          <p:cNvPicPr/>
          <p:nvPr/>
        </p:nvPicPr>
        <p:blipFill>
          <a:blip r:embed="rId1"/>
          <a:stretch/>
        </p:blipFill>
        <p:spPr>
          <a:xfrm>
            <a:off x="3687840" y="523800"/>
            <a:ext cx="1865160" cy="6334200"/>
          </a:xfrm>
          <a:prstGeom prst="rect">
            <a:avLst/>
          </a:prstGeom>
          <a:ln w="0">
            <a:noFill/>
          </a:ln>
        </p:spPr>
      </p:pic>
      <p:sp>
        <p:nvSpPr>
          <p:cNvPr id="42" name="TextBox 2"/>
          <p:cNvSpPr/>
          <p:nvPr/>
        </p:nvSpPr>
        <p:spPr>
          <a:xfrm>
            <a:off x="0" y="0"/>
            <a:ext cx="914400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Supplemental Table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. The prevalence of 37 HPV genotypes in clinician-collected and self-collected specimens. Bold type indicates statistically greater prevalence of that type as determined using an exact version of the McNemar’s tests.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6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3-21T14:35:42Z</dcterms:created>
  <dc:creator>Philip Castle</dc:creator>
  <dc:description/>
  <dc:language>en-US</dc:language>
  <cp:lastModifiedBy>Philip Castle</cp:lastModifiedBy>
  <dcterms:modified xsi:type="dcterms:W3CDTF">2012-04-11T14:08:41Z</dcterms:modified>
  <cp:revision>16</cp:revision>
  <dc:subject/>
  <dc:title>PowerPoint Presentation</dc:title>
</cp:coreProperties>
</file>